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C93293-59B4-4D92-A075-D5FEC4C18A49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450EB8-FD95-4C2B-B826-12CD585960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8990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. Loss of </a:t>
            </a:r>
            <a:r>
              <a:rPr lang="en-US" i="1" dirty="0"/>
              <a:t>rsr1</a:t>
            </a:r>
            <a:r>
              <a:rPr lang="en-US" dirty="0"/>
              <a:t> does not increase susceptibility to </a:t>
            </a:r>
            <a:r>
              <a:rPr lang="en-US" dirty="0" smtClean="0"/>
              <a:t>osmotic, oxidative</a:t>
            </a:r>
            <a:r>
              <a:rPr lang="en-US" dirty="0"/>
              <a:t>,</a:t>
            </a:r>
            <a:r>
              <a:rPr lang="en-US" baseline="0" dirty="0"/>
              <a:t> </a:t>
            </a:r>
            <a:r>
              <a:rPr lang="en-US" dirty="0"/>
              <a:t>membrane</a:t>
            </a:r>
            <a:r>
              <a:rPr lang="en-US" baseline="0" dirty="0"/>
              <a:t> or cell wall stress. </a:t>
            </a:r>
            <a:r>
              <a:rPr lang="en-US" baseline="0" dirty="0" smtClean="0"/>
              <a:t>Ten to 10,000 conidia </a:t>
            </a:r>
            <a:r>
              <a:rPr lang="en-US" baseline="0" dirty="0"/>
              <a:t>from each </a:t>
            </a:r>
            <a:r>
              <a:rPr lang="en-US" baseline="0" dirty="0" smtClean="0"/>
              <a:t>strain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were point‐inoculated onto glucose minimal medium (GMM) containing 1M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NaCl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1M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KCl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, 1.2M sorbitol, 80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g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ml of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lcofluor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white (CW), 80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μg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ml of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ngo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red (CR) or 0.0125% of sodium dodecyl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ulphate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(SDS). Plates were incubated at 37°C for 72 hr. For testing susceptibility to oxidative stress, GMM agar plates were inoculated with 10</a:t>
            </a:r>
            <a:r>
              <a:rPr lang="en-US" sz="1200" b="0" i="0" u="none" strike="noStrike" kern="1200" baseline="300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7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onidia and a perforation was made in the center of the plate and loaded with 50 </a:t>
            </a:r>
            <a:r>
              <a:rPr lang="el-GR" sz="1200" b="0" i="0" u="none" strike="noStrike" kern="1200" baseline="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μ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l of a 200mM H</a:t>
            </a:r>
            <a:r>
              <a:rPr lang="en-US" sz="1200" b="0" i="0" u="none" strike="noStrike" kern="1200" baseline="-2500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2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O</a:t>
            </a:r>
            <a:r>
              <a:rPr lang="en-US" sz="1200" b="0" i="0" u="none" strike="noStrike" kern="1200" baseline="-2500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2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 solution. Plates were incubated at 37°C and inhibition zone diameters were measured after 24h and compared between groups using</a:t>
            </a:r>
            <a:r>
              <a:rPr lang="en-US" dirty="0" smtClean="0"/>
              <a:t> unpaired, two-tailed, Student’s </a:t>
            </a:r>
            <a:r>
              <a:rPr lang="en-US" i="1" dirty="0" smtClean="0"/>
              <a:t>t </a:t>
            </a:r>
            <a:r>
              <a:rPr lang="en-US" dirty="0" smtClean="0"/>
              <a:t>test in </a:t>
            </a:r>
            <a:r>
              <a:rPr lang="en-US" dirty="0" err="1" smtClean="0"/>
              <a:t>GraphPad</a:t>
            </a:r>
            <a:r>
              <a:rPr lang="en-US" dirty="0" smtClean="0"/>
              <a:t> Prism v7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rPr>
              <a:t>. No significant differences were observed. Experiments were performed in biological triplicates.</a:t>
            </a: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A76B02A-5A1D-4C6E-BC2E-9D64FA7396C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9975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2139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78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0027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5636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7413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9687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8945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689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624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0585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697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374B41-D7DE-4189-BD51-4767DDE83C0D}" type="datetimeFigureOut">
              <a:rPr lang="en-US" smtClean="0"/>
              <a:t>9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C78D85-9909-4544-855F-657C9ADDB2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68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46" t="7656" r="9092" b="13396"/>
          <a:stretch/>
        </p:blipFill>
        <p:spPr>
          <a:xfrm>
            <a:off x="1689535" y="854625"/>
            <a:ext cx="1240683" cy="119997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056950" y="604086"/>
            <a:ext cx="5052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M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03700" y="602216"/>
            <a:ext cx="7168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M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aC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662306" y="602216"/>
            <a:ext cx="64152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M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C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810056" y="609955"/>
            <a:ext cx="987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1.2M Sorbito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513733" y="2298512"/>
            <a:ext cx="9140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0.015% SDS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82" t="9548" r="8871" b="11686"/>
          <a:stretch/>
        </p:blipFill>
        <p:spPr>
          <a:xfrm>
            <a:off x="3012939" y="850307"/>
            <a:ext cx="1240683" cy="120419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33" t="6655" r="9072" b="14361"/>
          <a:stretch/>
        </p:blipFill>
        <p:spPr>
          <a:xfrm>
            <a:off x="4332770" y="840580"/>
            <a:ext cx="1269174" cy="121391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13" t="7555" r="10059" b="13497"/>
          <a:stretch/>
        </p:blipFill>
        <p:spPr>
          <a:xfrm>
            <a:off x="5680831" y="840582"/>
            <a:ext cx="1246223" cy="120956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9" t="8002" r="14474" b="13053"/>
          <a:stretch/>
        </p:blipFill>
        <p:spPr>
          <a:xfrm>
            <a:off x="4332770" y="2531191"/>
            <a:ext cx="1269174" cy="122193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709432" y="971723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kuB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-pyrG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111472" y="1294758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42568" y="1637629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966" t="18908" r="31874" b="31845"/>
          <a:stretch/>
        </p:blipFill>
        <p:spPr>
          <a:xfrm>
            <a:off x="1689535" y="2532833"/>
            <a:ext cx="1240683" cy="1202510"/>
          </a:xfrm>
          <a:prstGeom prst="rect">
            <a:avLst/>
          </a:prstGeom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56" t="20853" r="33896" b="29402"/>
          <a:stretch/>
        </p:blipFill>
        <p:spPr>
          <a:xfrm>
            <a:off x="3014233" y="2531193"/>
            <a:ext cx="1243836" cy="1204151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1882555" y="2298512"/>
            <a:ext cx="9236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R 80 </a:t>
            </a:r>
            <a:r>
              <a:rPr lang="el-GR" sz="1000" b="1" dirty="0" smtClean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185880" y="2299163"/>
            <a:ext cx="9525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W 80 </a:t>
            </a:r>
            <a:r>
              <a:rPr lang="el-GR" sz="1000" b="1" smtClean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g/ml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102161" y="2967885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42568" y="3318606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7126" y="4373490"/>
            <a:ext cx="1234513" cy="123775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039" y="4373489"/>
            <a:ext cx="1237753" cy="123775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64193" y="4373489"/>
            <a:ext cx="1237753" cy="123775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853702" y="5611242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kuB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-pyrG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380645" y="5625328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40290" y="5625328"/>
            <a:ext cx="11849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+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FP-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rsrA</a:t>
            </a:r>
            <a:endParaRPr 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09262" y="2619821"/>
            <a:ext cx="9813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akuB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-pyrG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09262" y="4865405"/>
            <a:ext cx="9492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000" b="1" dirty="0"/>
              <a:t> H</a:t>
            </a:r>
            <a:r>
              <a:rPr lang="en-US" sz="1000" b="1" baseline="-25000" dirty="0"/>
              <a:t>2</a:t>
            </a:r>
            <a:r>
              <a:rPr lang="en-US" sz="1000" b="1" dirty="0"/>
              <a:t>O</a:t>
            </a:r>
            <a:r>
              <a:rPr lang="en-US" sz="1000" b="1" baseline="-25000" dirty="0"/>
              <a:t>2</a:t>
            </a:r>
          </a:p>
        </p:txBody>
      </p:sp>
    </p:spTree>
    <p:extLst>
      <p:ext uri="{BB962C8B-B14F-4D97-AF65-F5344CB8AC3E}">
        <p14:creationId xmlns:p14="http://schemas.microsoft.com/office/powerpoint/2010/main" val="36428843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</TotalTime>
  <Words>207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-Vicente, Adela</dc:creator>
  <cp:lastModifiedBy>Martin-Vicente, Adela</cp:lastModifiedBy>
  <cp:revision>2</cp:revision>
  <dcterms:created xsi:type="dcterms:W3CDTF">2020-09-15T20:09:53Z</dcterms:created>
  <dcterms:modified xsi:type="dcterms:W3CDTF">2020-09-29T19:25:03Z</dcterms:modified>
</cp:coreProperties>
</file>